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jpeg" ContentType="image/jpeg"/>
  <Override PartName="/ppt/media/image11.png" ContentType="image/png"/>
  <Override PartName="/ppt/media/image8.png" ContentType="image/png"/>
  <Override PartName="/ppt/media/image9.png" ContentType="image/png"/>
  <Override PartName="/ppt/media/image1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89D73-90C1-404E-A716-00EC6618E81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8360B-3DD9-43E3-B0D0-189218717E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98EBDE-2FAF-4C71-81F7-CE09892D77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B133FD-C541-4AE9-B73C-F969775395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2E5EAF-7F61-4C60-834C-239FA48B8B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7EA341-ECD4-4721-A161-1B3DB5B0E0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B629F6-0A8A-475E-A35B-2F59CC1EC8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B1070-1155-4255-87CB-8B4D74EF26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3A1C2-6F93-4FB0-8297-271AB3978B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5322A2-9FAF-4D6C-9812-A9ADDA7B98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A972B-C0DF-45BC-99CD-148AD1F241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406CFD-2620-4E5B-9183-718467550C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ＭＳ Ｐゴシック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ＭＳ Ｐゴシック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343DC64-C736-462F-A64A-044E957853F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4" descr=""/>
          <p:cNvPicPr/>
          <p:nvPr/>
        </p:nvPicPr>
        <p:blipFill>
          <a:blip r:embed="rId1"/>
          <a:stretch/>
        </p:blipFill>
        <p:spPr>
          <a:xfrm>
            <a:off x="871560" y="2925720"/>
            <a:ext cx="1365120" cy="1701720"/>
          </a:xfrm>
          <a:prstGeom prst="rect">
            <a:avLst/>
          </a:prstGeom>
          <a:ln w="0">
            <a:noFill/>
          </a:ln>
        </p:spPr>
      </p:pic>
      <p:sp>
        <p:nvSpPr>
          <p:cNvPr id="42" name="TextBox 8"/>
          <p:cNvSpPr/>
          <p:nvPr/>
        </p:nvSpPr>
        <p:spPr>
          <a:xfrm>
            <a:off x="1342440" y="3154320"/>
            <a:ext cx="64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Chart 13" descr=""/>
          <p:cNvPicPr/>
          <p:nvPr/>
        </p:nvPicPr>
        <p:blipFill>
          <a:blip r:embed="rId2"/>
          <a:stretch/>
        </p:blipFill>
        <p:spPr>
          <a:xfrm>
            <a:off x="3859200" y="3230640"/>
            <a:ext cx="1395360" cy="1530360"/>
          </a:xfrm>
          <a:prstGeom prst="rect">
            <a:avLst/>
          </a:prstGeom>
          <a:ln w="0">
            <a:noFill/>
          </a:ln>
        </p:spPr>
      </p:pic>
      <p:pic>
        <p:nvPicPr>
          <p:cNvPr id="44" name="Chart 14" descr=""/>
          <p:cNvPicPr/>
          <p:nvPr/>
        </p:nvPicPr>
        <p:blipFill>
          <a:blip r:embed="rId3"/>
          <a:stretch/>
        </p:blipFill>
        <p:spPr>
          <a:xfrm>
            <a:off x="2419200" y="3151080"/>
            <a:ext cx="1341720" cy="14209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3" descr=""/>
          <p:cNvPicPr/>
          <p:nvPr/>
        </p:nvPicPr>
        <p:blipFill>
          <a:blip r:embed="rId4"/>
          <a:stretch/>
        </p:blipFill>
        <p:spPr>
          <a:xfrm>
            <a:off x="1309680" y="5818320"/>
            <a:ext cx="755640" cy="33804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46" name="Picture 15" descr=""/>
          <p:cNvPicPr/>
          <p:nvPr/>
        </p:nvPicPr>
        <p:blipFill>
          <a:blip r:embed="rId5"/>
          <a:stretch/>
        </p:blipFill>
        <p:spPr>
          <a:xfrm>
            <a:off x="1309680" y="6267600"/>
            <a:ext cx="755640" cy="33804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47" name="Picture 18" descr=""/>
          <p:cNvPicPr/>
          <p:nvPr/>
        </p:nvPicPr>
        <p:blipFill>
          <a:blip r:embed="rId6"/>
          <a:stretch/>
        </p:blipFill>
        <p:spPr>
          <a:xfrm>
            <a:off x="1309680" y="6729480"/>
            <a:ext cx="755640" cy="33804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48" name="Picture 6" descr=""/>
          <p:cNvPicPr/>
          <p:nvPr/>
        </p:nvPicPr>
        <p:blipFill>
          <a:blip r:embed="rId7"/>
          <a:srcRect l="0" t="0" r="29906" b="18839"/>
          <a:stretch/>
        </p:blipFill>
        <p:spPr>
          <a:xfrm>
            <a:off x="4476600" y="6302520"/>
            <a:ext cx="750960" cy="36504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49" name="Picture 3" descr=""/>
          <p:cNvPicPr/>
          <p:nvPr/>
        </p:nvPicPr>
        <p:blipFill>
          <a:blip r:embed="rId8"/>
          <a:srcRect l="0" t="0" r="33395" b="-2804"/>
          <a:stretch/>
        </p:blipFill>
        <p:spPr>
          <a:xfrm>
            <a:off x="4476600" y="5857920"/>
            <a:ext cx="755640" cy="33804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50" name="Picture 35" descr=""/>
          <p:cNvPicPr/>
          <p:nvPr/>
        </p:nvPicPr>
        <p:blipFill>
          <a:blip r:embed="rId9"/>
          <a:srcRect l="0" t="0" r="34281" b="0"/>
          <a:stretch/>
        </p:blipFill>
        <p:spPr>
          <a:xfrm>
            <a:off x="4476600" y="6746760"/>
            <a:ext cx="755640" cy="33840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sp>
        <p:nvSpPr>
          <p:cNvPr id="51" name="TextBox 36"/>
          <p:cNvSpPr/>
          <p:nvPr/>
        </p:nvSpPr>
        <p:spPr>
          <a:xfrm>
            <a:off x="376560" y="6762600"/>
            <a:ext cx="874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37"/>
          <p:cNvSpPr/>
          <p:nvPr/>
        </p:nvSpPr>
        <p:spPr>
          <a:xfrm>
            <a:off x="540360" y="5835600"/>
            <a:ext cx="70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RC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38"/>
          <p:cNvSpPr/>
          <p:nvPr/>
        </p:nvSpPr>
        <p:spPr>
          <a:xfrm>
            <a:off x="556920" y="6284880"/>
            <a:ext cx="68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OX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39"/>
          <p:cNvSpPr/>
          <p:nvPr/>
        </p:nvSpPr>
        <p:spPr>
          <a:xfrm>
            <a:off x="2678760" y="3170160"/>
            <a:ext cx="111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40"/>
          <p:cNvSpPr/>
          <p:nvPr/>
        </p:nvSpPr>
        <p:spPr>
          <a:xfrm>
            <a:off x="4153320" y="3184560"/>
            <a:ext cx="111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DA-MB-43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42"/>
          <p:cNvSpPr/>
          <p:nvPr/>
        </p:nvSpPr>
        <p:spPr>
          <a:xfrm>
            <a:off x="1314720" y="5487840"/>
            <a:ext cx="64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43"/>
          <p:cNvSpPr/>
          <p:nvPr/>
        </p:nvSpPr>
        <p:spPr>
          <a:xfrm>
            <a:off x="2756520" y="5502240"/>
            <a:ext cx="111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44"/>
          <p:cNvSpPr/>
          <p:nvPr/>
        </p:nvSpPr>
        <p:spPr>
          <a:xfrm>
            <a:off x="4273920" y="5516640"/>
            <a:ext cx="111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DA-MB-43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45"/>
          <p:cNvSpPr/>
          <p:nvPr/>
        </p:nvSpPr>
        <p:spPr>
          <a:xfrm>
            <a:off x="269640" y="253224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46"/>
          <p:cNvSpPr/>
          <p:nvPr/>
        </p:nvSpPr>
        <p:spPr>
          <a:xfrm rot="16200000">
            <a:off x="-79920" y="3792600"/>
            <a:ext cx="150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OXA1/L19 m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47"/>
          <p:cNvSpPr/>
          <p:nvPr/>
        </p:nvSpPr>
        <p:spPr>
          <a:xfrm>
            <a:off x="270000" y="5297400"/>
            <a:ext cx="366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48"/>
          <p:cNvSpPr/>
          <p:nvPr/>
        </p:nvSpPr>
        <p:spPr>
          <a:xfrm rot="18900000">
            <a:off x="914040" y="7323120"/>
            <a:ext cx="77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49"/>
          <p:cNvSpPr/>
          <p:nvPr/>
        </p:nvSpPr>
        <p:spPr>
          <a:xfrm rot="18900000">
            <a:off x="1339200" y="7299720"/>
            <a:ext cx="70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RC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52"/>
          <p:cNvSpPr/>
          <p:nvPr/>
        </p:nvSpPr>
        <p:spPr>
          <a:xfrm rot="18900000">
            <a:off x="2657520" y="7342560"/>
            <a:ext cx="77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53"/>
          <p:cNvSpPr/>
          <p:nvPr/>
        </p:nvSpPr>
        <p:spPr>
          <a:xfrm rot="18900000">
            <a:off x="3082680" y="7318440"/>
            <a:ext cx="70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RC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54"/>
          <p:cNvSpPr/>
          <p:nvPr/>
        </p:nvSpPr>
        <p:spPr>
          <a:xfrm rot="18900000">
            <a:off x="4122720" y="7336080"/>
            <a:ext cx="77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55"/>
          <p:cNvSpPr/>
          <p:nvPr/>
        </p:nvSpPr>
        <p:spPr>
          <a:xfrm rot="18900000">
            <a:off x="4547520" y="7312320"/>
            <a:ext cx="70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RC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56"/>
          <p:cNvSpPr/>
          <p:nvPr/>
        </p:nvSpPr>
        <p:spPr>
          <a:xfrm rot="18900000">
            <a:off x="940320" y="4660200"/>
            <a:ext cx="77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57"/>
          <p:cNvSpPr/>
          <p:nvPr/>
        </p:nvSpPr>
        <p:spPr>
          <a:xfrm rot="18900000">
            <a:off x="1365120" y="4637160"/>
            <a:ext cx="70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RC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60"/>
          <p:cNvSpPr/>
          <p:nvPr/>
        </p:nvSpPr>
        <p:spPr>
          <a:xfrm rot="18900000">
            <a:off x="2536560" y="4680000"/>
            <a:ext cx="77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61"/>
          <p:cNvSpPr/>
          <p:nvPr/>
        </p:nvSpPr>
        <p:spPr>
          <a:xfrm rot="18900000">
            <a:off x="2960640" y="4656240"/>
            <a:ext cx="70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RC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62"/>
          <p:cNvSpPr/>
          <p:nvPr/>
        </p:nvSpPr>
        <p:spPr>
          <a:xfrm rot="18900000">
            <a:off x="4000680" y="4673160"/>
            <a:ext cx="77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63"/>
          <p:cNvSpPr/>
          <p:nvPr/>
        </p:nvSpPr>
        <p:spPr>
          <a:xfrm rot="18900000">
            <a:off x="4425840" y="4649760"/>
            <a:ext cx="70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RC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" name="Picture 2" descr=""/>
          <p:cNvPicPr/>
          <p:nvPr/>
        </p:nvPicPr>
        <p:blipFill>
          <a:blip r:embed="rId10"/>
          <a:srcRect l="0" t="2911" r="33911" b="0"/>
          <a:stretch/>
        </p:blipFill>
        <p:spPr>
          <a:xfrm>
            <a:off x="2884320" y="5848200"/>
            <a:ext cx="766800" cy="34308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75" name="Picture 2" descr=""/>
          <p:cNvPicPr/>
          <p:nvPr/>
        </p:nvPicPr>
        <p:blipFill>
          <a:blip r:embed="rId11"/>
          <a:srcRect l="34297" t="7299" r="0" b="0"/>
          <a:stretch/>
        </p:blipFill>
        <p:spPr>
          <a:xfrm>
            <a:off x="2884320" y="6299280"/>
            <a:ext cx="755640" cy="34272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76" name="Picture 2" descr=""/>
          <p:cNvPicPr/>
          <p:nvPr/>
        </p:nvPicPr>
        <p:blipFill>
          <a:blip r:embed="rId12"/>
          <a:srcRect l="34533" t="0" r="0" b="0"/>
          <a:stretch/>
        </p:blipFill>
        <p:spPr>
          <a:xfrm>
            <a:off x="2884320" y="6738840"/>
            <a:ext cx="755640" cy="34128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cxnSp>
        <p:nvCxnSpPr>
          <p:cNvPr id="77" name="Straight Arrow Connector 67"/>
          <p:cNvCxnSpPr/>
          <p:nvPr/>
        </p:nvCxnSpPr>
        <p:spPr>
          <a:xfrm flipH="1">
            <a:off x="3711240" y="6525720"/>
            <a:ext cx="26712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8" name="TextBox 69"/>
          <p:cNvSpPr/>
          <p:nvPr/>
        </p:nvSpPr>
        <p:spPr>
          <a:xfrm>
            <a:off x="5080680" y="9609120"/>
            <a:ext cx="178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 S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Left Brace 1"/>
          <p:cNvSpPr/>
          <p:nvPr/>
        </p:nvSpPr>
        <p:spPr>
          <a:xfrm rot="5400000">
            <a:off x="4665960" y="3364560"/>
            <a:ext cx="155520" cy="576360"/>
          </a:xfrm>
          <a:custGeom>
            <a:avLst/>
            <a:gdLst>
              <a:gd name="textAreaLeft" fmla="*/ 99360 w 155520"/>
              <a:gd name="textAreaRight" fmla="*/ 155520 w 155520"/>
              <a:gd name="textAreaTop" fmla="*/ 3960 h 576360"/>
              <a:gd name="textAreaBottom" fmla="*/ 572400 h 576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243"/>
                  <a:pt x="10800" y="486"/>
                </a:cubicBezTo>
                <a:lnTo>
                  <a:pt x="10800" y="10314"/>
                </a:lnTo>
                <a:cubicBezTo>
                  <a:pt x="10800" y="10557"/>
                  <a:pt x="5400" y="10800"/>
                  <a:pt x="0" y="10800"/>
                </a:cubicBezTo>
                <a:cubicBezTo>
                  <a:pt x="5400" y="10800"/>
                  <a:pt x="10800" y="11043"/>
                  <a:pt x="10800" y="11286"/>
                </a:cubicBezTo>
                <a:lnTo>
                  <a:pt x="10800" y="21114"/>
                </a:lnTo>
                <a:cubicBezTo>
                  <a:pt x="10800" y="21357"/>
                  <a:pt x="16200" y="21600"/>
                  <a:pt x="2160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Left Brace 70"/>
          <p:cNvSpPr/>
          <p:nvPr/>
        </p:nvSpPr>
        <p:spPr>
          <a:xfrm rot="5400000">
            <a:off x="3167280" y="3337560"/>
            <a:ext cx="155520" cy="576360"/>
          </a:xfrm>
          <a:custGeom>
            <a:avLst/>
            <a:gdLst>
              <a:gd name="textAreaLeft" fmla="*/ 99360 w 155520"/>
              <a:gd name="textAreaRight" fmla="*/ 155520 w 155520"/>
              <a:gd name="textAreaTop" fmla="*/ 3960 h 576360"/>
              <a:gd name="textAreaBottom" fmla="*/ 572400 h 576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243"/>
                  <a:pt x="10800" y="486"/>
                </a:cubicBezTo>
                <a:lnTo>
                  <a:pt x="10800" y="10314"/>
                </a:lnTo>
                <a:cubicBezTo>
                  <a:pt x="10800" y="10557"/>
                  <a:pt x="5400" y="10800"/>
                  <a:pt x="0" y="10800"/>
                </a:cubicBezTo>
                <a:cubicBezTo>
                  <a:pt x="5400" y="10800"/>
                  <a:pt x="10800" y="11043"/>
                  <a:pt x="10800" y="11286"/>
                </a:cubicBezTo>
                <a:lnTo>
                  <a:pt x="10800" y="21114"/>
                </a:lnTo>
                <a:cubicBezTo>
                  <a:pt x="10800" y="21357"/>
                  <a:pt x="16200" y="21600"/>
                  <a:pt x="2160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2"/>
          <p:cNvSpPr/>
          <p:nvPr/>
        </p:nvSpPr>
        <p:spPr>
          <a:xfrm>
            <a:off x="4584600" y="33447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71"/>
          <p:cNvSpPr/>
          <p:nvPr/>
        </p:nvSpPr>
        <p:spPr>
          <a:xfrm flipH="1">
            <a:off x="3100320" y="3322800"/>
            <a:ext cx="455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16T23:48:49Z</dcterms:created>
  <dc:creator>Jade Gong</dc:creator>
  <dc:description/>
  <dc:language>en-US</dc:language>
  <cp:lastModifiedBy>ravikumar.n</cp:lastModifiedBy>
  <cp:lastPrinted>2014-09-26T09:57:40Z</cp:lastPrinted>
  <dcterms:modified xsi:type="dcterms:W3CDTF">2014-12-10T19:34:40Z</dcterms:modified>
  <cp:revision>596</cp:revision>
  <dc:subject/>
  <dc:title>PowerPoint Presentation</dc:title>
</cp:coreProperties>
</file>